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211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875558" y="3707904"/>
            <a:ext cx="295705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protein transferred PVDF membranes were cut depend on molecular weight of target proteins.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グループ化 7"/>
          <p:cNvGrpSpPr/>
          <p:nvPr/>
        </p:nvGrpSpPr>
        <p:grpSpPr>
          <a:xfrm>
            <a:off x="980728" y="525452"/>
            <a:ext cx="2829981" cy="4046548"/>
            <a:chOff x="476672" y="251741"/>
            <a:chExt cx="3424277" cy="4896323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672" y="251741"/>
              <a:ext cx="3424277" cy="48963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正方形/長方形 2"/>
            <p:cNvSpPr/>
            <p:nvPr/>
          </p:nvSpPr>
          <p:spPr>
            <a:xfrm>
              <a:off x="1449650" y="2267965"/>
              <a:ext cx="1440160" cy="431937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1449650" y="2743557"/>
              <a:ext cx="1440160" cy="431937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629863" y="2369835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A: Fstl1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592493" y="2826266"/>
              <a:ext cx="861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: Fstl1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/>
          <p:cNvGrpSpPr/>
          <p:nvPr/>
        </p:nvGrpSpPr>
        <p:grpSpPr>
          <a:xfrm>
            <a:off x="3613371" y="539552"/>
            <a:ext cx="3046464" cy="2927566"/>
            <a:chOff x="208739" y="3635896"/>
            <a:chExt cx="3686217" cy="354235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654" y="3635896"/>
              <a:ext cx="3361302" cy="3542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正方形/長方形 12"/>
            <p:cNvSpPr/>
            <p:nvPr/>
          </p:nvSpPr>
          <p:spPr>
            <a:xfrm>
              <a:off x="1393726" y="4912990"/>
              <a:ext cx="1440160" cy="431937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正方形/長方形 13"/>
            <p:cNvSpPr/>
            <p:nvPr/>
          </p:nvSpPr>
          <p:spPr>
            <a:xfrm>
              <a:off x="1393726" y="6429461"/>
              <a:ext cx="1440160" cy="431937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208739" y="5044988"/>
              <a:ext cx="10566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M: GAPDH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290271" y="6565173"/>
              <a:ext cx="10070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A: GAPDH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/>
          <p:cNvSpPr txBox="1"/>
          <p:nvPr/>
        </p:nvSpPr>
        <p:spPr>
          <a:xfrm>
            <a:off x="-27384" y="170220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3243975"/>
              </p:ext>
            </p:extLst>
          </p:nvPr>
        </p:nvGraphicFramePr>
        <p:xfrm>
          <a:off x="188638" y="5295096"/>
          <a:ext cx="6471196" cy="338136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85526"/>
                <a:gridCol w="997134"/>
                <a:gridCol w="997134"/>
                <a:gridCol w="997134"/>
                <a:gridCol w="997134"/>
                <a:gridCol w="997134"/>
              </a:tblGrid>
              <a:tr h="29111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igure 1A 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schemic Area: Fstl1/GAPD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(days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basel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.91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0.31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2.69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4.38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.735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6.10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0.73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2.07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2.09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1.05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8.56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2.96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mote Area: Fstl1/GAPD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(days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basel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093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313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.3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57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748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456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339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410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575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95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456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.36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.2994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65807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18"/>
          <p:cNvGrpSpPr/>
          <p:nvPr/>
        </p:nvGrpSpPr>
        <p:grpSpPr>
          <a:xfrm>
            <a:off x="539504" y="882393"/>
            <a:ext cx="3218688" cy="2145792"/>
            <a:chOff x="154027" y="4661495"/>
            <a:chExt cx="3218688" cy="2145792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4027" y="4661495"/>
              <a:ext cx="3218688" cy="21457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正方形/長方形 22"/>
            <p:cNvSpPr/>
            <p:nvPr/>
          </p:nvSpPr>
          <p:spPr>
            <a:xfrm>
              <a:off x="839412" y="5418000"/>
              <a:ext cx="983649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テキスト ボックス 23"/>
            <p:cNvSpPr txBox="1"/>
            <p:nvPr/>
          </p:nvSpPr>
          <p:spPr>
            <a:xfrm>
              <a:off x="548680" y="5148064"/>
              <a:ext cx="10567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um Fstl1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19"/>
          <p:cNvGrpSpPr/>
          <p:nvPr/>
        </p:nvGrpSpPr>
        <p:grpSpPr>
          <a:xfrm>
            <a:off x="3814477" y="751151"/>
            <a:ext cx="2782875" cy="2332286"/>
            <a:chOff x="3429000" y="4615978"/>
            <a:chExt cx="2782875" cy="2332286"/>
          </a:xfrm>
        </p:grpSpPr>
        <p:pic>
          <p:nvPicPr>
            <p:cNvPr id="8" name="Picture 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4615978"/>
              <a:ext cx="2782875" cy="2332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正方形/長方形 26"/>
            <p:cNvSpPr/>
            <p:nvPr/>
          </p:nvSpPr>
          <p:spPr>
            <a:xfrm>
              <a:off x="3683124" y="5003232"/>
              <a:ext cx="1082014" cy="69563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テキスト ボックス 27"/>
            <p:cNvSpPr txBox="1"/>
            <p:nvPr/>
          </p:nvSpPr>
          <p:spPr>
            <a:xfrm>
              <a:off x="3634536" y="4755624"/>
              <a:ext cx="9348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テキスト ボックス 1"/>
          <p:cNvSpPr txBox="1"/>
          <p:nvPr/>
        </p:nvSpPr>
        <p:spPr>
          <a:xfrm>
            <a:off x="-27384" y="467544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7201579"/>
              </p:ext>
            </p:extLst>
          </p:nvPr>
        </p:nvGraphicFramePr>
        <p:xfrm>
          <a:off x="527463" y="4067944"/>
          <a:ext cx="4889965" cy="249610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22540"/>
                <a:gridCol w="753485"/>
                <a:gridCol w="753485"/>
                <a:gridCol w="753485"/>
                <a:gridCol w="753485"/>
                <a:gridCol w="753485"/>
              </a:tblGrid>
              <a:tr h="39572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Figure 1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5006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erum Fstl1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5006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(days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5006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519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026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859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56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5006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1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458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3.191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53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5006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86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617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320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549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5006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66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636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211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.1724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45379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123</Words>
  <Application>Microsoft Office PowerPoint</Application>
  <PresentationFormat>On-screen Show (4:3)</PresentationFormat>
  <Paragraphs>8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ＭＳ Ｐゴシック</vt:lpstr>
      <vt:lpstr>Arial</vt:lpstr>
      <vt:lpstr>Calibri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8</cp:revision>
  <dcterms:modified xsi:type="dcterms:W3CDTF">2016-04-22T18:39:02Z</dcterms:modified>
</cp:coreProperties>
</file>